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4"/>
  </p:notesMasterIdLst>
  <p:sldIdLst>
    <p:sldId id="258" r:id="rId2"/>
    <p:sldId id="259" r:id="rId3"/>
  </p:sldIdLst>
  <p:sldSz cx="20116800" cy="9144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2ECE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43" d="100"/>
          <a:sy n="43" d="100"/>
        </p:scale>
        <p:origin x="1162" y="5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DF8D71-2C6D-4D5F-A691-B6C7BC485D7C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27238" y="857250"/>
            <a:ext cx="50895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EC5557-DA20-4287-86A0-6EA5EC133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157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14600" y="1496484"/>
            <a:ext cx="150876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514600" y="4802717"/>
            <a:ext cx="150876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12319-4897-402E-BF86-E535422CB92F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FF78F-092B-4788-A984-AA16A063EF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15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12319-4897-402E-BF86-E535422CB92F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FF78F-092B-4788-A984-AA16A063EF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547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396085" y="486834"/>
            <a:ext cx="4337685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83030" y="486834"/>
            <a:ext cx="12761595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12319-4897-402E-BF86-E535422CB92F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FF78F-092B-4788-A984-AA16A063EF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927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12319-4897-402E-BF86-E535422CB92F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FF78F-092B-4788-A984-AA16A063EF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1359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72553" y="2279652"/>
            <a:ext cx="1735074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72553" y="6119285"/>
            <a:ext cx="1735074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12319-4897-402E-BF86-E535422CB92F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FF78F-092B-4788-A984-AA16A063EF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193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83030" y="2434167"/>
            <a:ext cx="854964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184130" y="2434167"/>
            <a:ext cx="854964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12319-4897-402E-BF86-E535422CB92F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FF78F-092B-4788-A984-AA16A063EF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321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85650" y="486834"/>
            <a:ext cx="1735074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85651" y="2241551"/>
            <a:ext cx="8510349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5651" y="3340100"/>
            <a:ext cx="8510349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184130" y="2241551"/>
            <a:ext cx="8552260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184130" y="3340100"/>
            <a:ext cx="8552260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12319-4897-402E-BF86-E535422CB92F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FF78F-092B-4788-A984-AA16A063EF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788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12319-4897-402E-BF86-E535422CB92F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FF78F-092B-4788-A984-AA16A063EF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416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12319-4897-402E-BF86-E535422CB92F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FF78F-092B-4788-A984-AA16A063EF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46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85651" y="609600"/>
            <a:ext cx="6488191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552260" y="1316567"/>
            <a:ext cx="1018413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85651" y="2743200"/>
            <a:ext cx="6488191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12319-4897-402E-BF86-E535422CB92F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FF78F-092B-4788-A984-AA16A063EF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354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85651" y="609600"/>
            <a:ext cx="6488191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552260" y="1316567"/>
            <a:ext cx="1018413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85651" y="2743200"/>
            <a:ext cx="6488191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12319-4897-402E-BF86-E535422CB92F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FF78F-092B-4788-A984-AA16A063EF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884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83030" y="486834"/>
            <a:ext cx="1735074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83030" y="2434167"/>
            <a:ext cx="1735074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83030" y="8475134"/>
            <a:ext cx="45262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C12319-4897-402E-BF86-E535422CB92F}" type="datetimeFigureOut">
              <a:rPr lang="en-US" smtClean="0"/>
              <a:t>1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663690" y="8475134"/>
            <a:ext cx="67894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4207490" y="8475134"/>
            <a:ext cx="45262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9FF78F-092B-4788-A984-AA16A063EF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352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C491D0E-3FBF-CE01-B384-AFABAF4F3755}"/>
              </a:ext>
            </a:extLst>
          </p:cNvPr>
          <p:cNvSpPr txBox="1"/>
          <p:nvPr/>
        </p:nvSpPr>
        <p:spPr>
          <a:xfrm>
            <a:off x="1031653" y="279913"/>
            <a:ext cx="4743613" cy="549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97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</a:t>
            </a:r>
          </a:p>
        </p:txBody>
      </p:sp>
      <p:pic>
        <p:nvPicPr>
          <p:cNvPr id="6" name="Picture 5" descr="A person standing next to a white background&#10;&#10;AI-generated content may be incorrect.">
            <a:extLst>
              <a:ext uri="{FF2B5EF4-FFF2-40B4-BE49-F238E27FC236}">
                <a16:creationId xmlns:a16="http://schemas.microsoft.com/office/drawing/2014/main" id="{C36EA16F-D73D-8456-23B1-CE38286C69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329" y="1338942"/>
            <a:ext cx="17942765" cy="5366874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44A36F23-84E5-8D83-C6C7-84C76E9B69CD}"/>
              </a:ext>
            </a:extLst>
          </p:cNvPr>
          <p:cNvSpPr/>
          <p:nvPr/>
        </p:nvSpPr>
        <p:spPr>
          <a:xfrm>
            <a:off x="11906564" y="934813"/>
            <a:ext cx="177819" cy="615896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28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CCF3911F-6B0B-6B0A-4C8C-C8055DA9624B}"/>
              </a:ext>
            </a:extLst>
          </p:cNvPr>
          <p:cNvCxnSpPr/>
          <p:nvPr/>
        </p:nvCxnSpPr>
        <p:spPr>
          <a:xfrm flipH="1">
            <a:off x="12252828" y="1338942"/>
            <a:ext cx="2144720" cy="0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09FB59C0-A0FC-CBFB-E9E0-94D517C62EAA}"/>
              </a:ext>
            </a:extLst>
          </p:cNvPr>
          <p:cNvSpPr txBox="1"/>
          <p:nvPr/>
        </p:nvSpPr>
        <p:spPr>
          <a:xfrm>
            <a:off x="902330" y="7296047"/>
            <a:ext cx="18476921" cy="14637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22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conservation analysis (</a:t>
            </a:r>
            <a:r>
              <a:rPr lang="en-GB" sz="222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us_species|gene|UniProt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try ID) demonstrates conservation of the Pro565 residue in the 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LDLR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across the following twelve species: 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scrofa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ig), 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is lupus </a:t>
            </a:r>
            <a:r>
              <a:rPr lang="en-GB" sz="222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miliaris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og), </a:t>
            </a:r>
            <a:r>
              <a:rPr lang="en-GB" sz="222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culus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22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culus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esser Egyptian jerboa), 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thera </a:t>
            </a:r>
            <a:r>
              <a:rPr lang="en-GB" sz="222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o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ion), 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s musculus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ouse), 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tus norvegicus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at), 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 troglodytes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himpanzee), 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s taurus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ow), 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yctolagus cuniculus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abbit), 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iurus vulgaris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urasian red squirrel), 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mo sapiens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uman), and </a:t>
            </a:r>
            <a:r>
              <a:rPr lang="en-GB" sz="222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inopithecus</a:t>
            </a:r>
            <a:r>
              <a:rPr lang="en-GB" sz="222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22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xellana</a:t>
            </a:r>
            <a:r>
              <a:rPr lang="en-GB" sz="222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olden snub-nosed monkey). </a:t>
            </a:r>
            <a:endParaRPr lang="en-US" sz="222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0516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E673E08-089F-EA3C-EAF2-DA0E12E5C8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753" y="1439516"/>
            <a:ext cx="17068798" cy="504241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D19E0E1-EE28-ACAF-DD3E-127441A5DA6D}"/>
              </a:ext>
            </a:extLst>
          </p:cNvPr>
          <p:cNvSpPr txBox="1"/>
          <p:nvPr/>
        </p:nvSpPr>
        <p:spPr>
          <a:xfrm>
            <a:off x="753035" y="504079"/>
            <a:ext cx="474361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AF9776E-11A8-D504-5DCC-3E5728C127E8}"/>
              </a:ext>
            </a:extLst>
          </p:cNvPr>
          <p:cNvSpPr txBox="1"/>
          <p:nvPr/>
        </p:nvSpPr>
        <p:spPr>
          <a:xfrm>
            <a:off x="681317" y="6877711"/>
            <a:ext cx="1943548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conservation analysis (</a:t>
            </a:r>
            <a:r>
              <a:rPr lang="en-GB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us_species|gene|UniProt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try ID) demonstrates conservation of the Pro565 residue in the 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LDLR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across the following twelve species: 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scrofa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ig), 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is lupus </a:t>
            </a:r>
            <a:r>
              <a:rPr lang="en-GB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miliaris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og), </a:t>
            </a:r>
            <a:r>
              <a:rPr lang="en-GB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culus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culus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esser Egyptian jerboa), 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thera </a:t>
            </a:r>
            <a:r>
              <a:rPr lang="en-GB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o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ion), 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s musculus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ouse), 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tus norvegicus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at), 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 troglodytes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himpanzee), 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s taurus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ow), 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yctolagus cuniculus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abbit), 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iurus vulgaris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urasian red squirrel), 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mo sapiens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uman), and </a:t>
            </a:r>
            <a:r>
              <a:rPr lang="en-GB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inopithecus</a:t>
            </a:r>
            <a:r>
              <a:rPr lang="en-GB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xellana</a:t>
            </a:r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olden snub-nosed monkey).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627B05F-57AF-1A94-06B0-9CC17BF34234}"/>
              </a:ext>
            </a:extLst>
          </p:cNvPr>
          <p:cNvSpPr/>
          <p:nvPr/>
        </p:nvSpPr>
        <p:spPr>
          <a:xfrm>
            <a:off x="11331389" y="735264"/>
            <a:ext cx="143436" cy="615896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28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4BC0FD5A-6C03-9E31-AF47-627952E04E3D}"/>
              </a:ext>
            </a:extLst>
          </p:cNvPr>
          <p:cNvCxnSpPr/>
          <p:nvPr/>
        </p:nvCxnSpPr>
        <p:spPr>
          <a:xfrm flipH="1">
            <a:off x="11607369" y="1027299"/>
            <a:ext cx="2144720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32669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7</TotalTime>
  <Words>210</Words>
  <Application>Microsoft Office PowerPoint</Application>
  <PresentationFormat>Custom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riq Jawabri</dc:creator>
  <cp:lastModifiedBy>Tariq Jawabri</cp:lastModifiedBy>
  <cp:revision>12</cp:revision>
  <dcterms:created xsi:type="dcterms:W3CDTF">2025-10-10T14:25:16Z</dcterms:created>
  <dcterms:modified xsi:type="dcterms:W3CDTF">2026-01-19T19:38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3d7eded-5fbb-4e74-baac-4decc5b8fd35_Enabled">
    <vt:lpwstr>true</vt:lpwstr>
  </property>
  <property fmtid="{D5CDD505-2E9C-101B-9397-08002B2CF9AE}" pid="3" name="MSIP_Label_d3d7eded-5fbb-4e74-baac-4decc5b8fd35_SetDate">
    <vt:lpwstr>2025-10-10T14:31:33Z</vt:lpwstr>
  </property>
  <property fmtid="{D5CDD505-2E9C-101B-9397-08002B2CF9AE}" pid="4" name="MSIP_Label_d3d7eded-5fbb-4e74-baac-4decc5b8fd35_Method">
    <vt:lpwstr>Standard</vt:lpwstr>
  </property>
  <property fmtid="{D5CDD505-2E9C-101B-9397-08002B2CF9AE}" pid="5" name="MSIP_Label_d3d7eded-5fbb-4e74-baac-4decc5b8fd35_Name">
    <vt:lpwstr>Liwa Label</vt:lpwstr>
  </property>
  <property fmtid="{D5CDD505-2E9C-101B-9397-08002B2CF9AE}" pid="6" name="MSIP_Label_d3d7eded-5fbb-4e74-baac-4decc5b8fd35_SiteId">
    <vt:lpwstr>83c04ed0-6d35-44e6-84ff-3ee7129a9c48</vt:lpwstr>
  </property>
  <property fmtid="{D5CDD505-2E9C-101B-9397-08002B2CF9AE}" pid="7" name="MSIP_Label_d3d7eded-5fbb-4e74-baac-4decc5b8fd35_ActionId">
    <vt:lpwstr>a534a67c-7cd1-4d4e-93dc-2cc8d1af2391</vt:lpwstr>
  </property>
  <property fmtid="{D5CDD505-2E9C-101B-9397-08002B2CF9AE}" pid="8" name="MSIP_Label_d3d7eded-5fbb-4e74-baac-4decc5b8fd35_ContentBits">
    <vt:lpwstr>0</vt:lpwstr>
  </property>
  <property fmtid="{D5CDD505-2E9C-101B-9397-08002B2CF9AE}" pid="9" name="MSIP_Label_d3d7eded-5fbb-4e74-baac-4decc5b8fd35_Tag">
    <vt:lpwstr>10, 3, 0, 1</vt:lpwstr>
  </property>
</Properties>
</file>